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4572000" cy="50292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870200" y="685440"/>
            <a:ext cx="31176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264"/>
              </a:spcBef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fld id="{EE8E8BD1-674A-450B-A865-24BE9213C426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sldImg"/>
          </p:nvPr>
        </p:nvSpPr>
        <p:spPr>
          <a:xfrm>
            <a:off x="1870200" y="685800"/>
            <a:ext cx="3117600" cy="3429000"/>
          </a:xfrm>
          <a:prstGeom prst="rect">
            <a:avLst/>
          </a:prstGeom>
          <a:ln w="0">
            <a:noFill/>
          </a:ln>
        </p:spPr>
      </p:sp>
      <p:sp>
        <p:nvSpPr>
          <p:cNvPr id="7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264"/>
              </a:spcBef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fld id="{67FBF7CF-4A9F-41B1-9F4B-1BBED2DE552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2EE917-6B38-4A3E-8211-92C08A4882F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28600" y="201600"/>
            <a:ext cx="4114800" cy="8380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ctr">
            <a:noAutofit/>
          </a:bodyPr>
          <a:p>
            <a:pPr indent="0" algn="ctr"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28600" y="1172880"/>
            <a:ext cx="4114800" cy="15832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28600" y="2907000"/>
            <a:ext cx="4114800" cy="15832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2E5F73-76A8-402D-9DD0-154E9C64BA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28600" y="201600"/>
            <a:ext cx="4114800" cy="8380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ctr">
            <a:noAutofit/>
          </a:bodyPr>
          <a:p>
            <a:pPr indent="0" algn="ctr"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28600" y="1172880"/>
            <a:ext cx="2007720" cy="15832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337120" y="1172880"/>
            <a:ext cx="2007720" cy="15832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28600" y="2907000"/>
            <a:ext cx="2007720" cy="15832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337120" y="2907000"/>
            <a:ext cx="2007720" cy="15832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4DE1A9-336A-40C1-8112-2D6E6405AC9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28600" y="201600"/>
            <a:ext cx="4114800" cy="8380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ctr">
            <a:noAutofit/>
          </a:bodyPr>
          <a:p>
            <a:pPr indent="0" algn="ctr"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28600" y="1172880"/>
            <a:ext cx="1324800" cy="15832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620000" y="1172880"/>
            <a:ext cx="1324800" cy="15832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011400" y="1172880"/>
            <a:ext cx="1324800" cy="15832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28600" y="2907000"/>
            <a:ext cx="1324800" cy="15832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620000" y="2907000"/>
            <a:ext cx="1324800" cy="15832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011400" y="2907000"/>
            <a:ext cx="1324800" cy="15832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98CCEB-7663-4654-AF02-E97802EB0D4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28600" y="201600"/>
            <a:ext cx="4114800" cy="8380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ctr">
            <a:noAutofit/>
          </a:bodyPr>
          <a:p>
            <a:pPr indent="0" algn="ctr"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28600" y="1172880"/>
            <a:ext cx="4114800" cy="331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76"/>
              </a:spcBef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F49E3A-029D-45BA-A109-2B783799D4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28600" y="201600"/>
            <a:ext cx="4114800" cy="8380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ctr">
            <a:noAutofit/>
          </a:bodyPr>
          <a:p>
            <a:pPr indent="0" algn="ctr"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28600" y="1172880"/>
            <a:ext cx="4114800" cy="331956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425D8E-182D-4F02-AE5F-95BF1904F7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28600" y="201600"/>
            <a:ext cx="4114800" cy="8380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ctr">
            <a:noAutofit/>
          </a:bodyPr>
          <a:p>
            <a:pPr indent="0" algn="ctr"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28600" y="1172880"/>
            <a:ext cx="2007720" cy="331956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337120" y="1172880"/>
            <a:ext cx="2007720" cy="331956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22CFAD-658D-4229-8522-A7746D9681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28600" y="201600"/>
            <a:ext cx="4114800" cy="8380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ctr">
            <a:noAutofit/>
          </a:bodyPr>
          <a:p>
            <a:pPr indent="0" algn="ctr"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FCBE75-CBB1-4833-A7C0-CDE4B176F55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28600" y="201600"/>
            <a:ext cx="4114800" cy="3886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76"/>
              </a:spcBef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37D09D-692A-4213-9FB9-409818F91F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28600" y="201600"/>
            <a:ext cx="4114800" cy="8380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ctr">
            <a:noAutofit/>
          </a:bodyPr>
          <a:p>
            <a:pPr indent="0" algn="ctr"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28600" y="1172880"/>
            <a:ext cx="2007720" cy="15832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337120" y="1172880"/>
            <a:ext cx="2007720" cy="331956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28600" y="2907000"/>
            <a:ext cx="2007720" cy="15832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20B310-5708-41D2-9720-55FF8894E4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28600" y="201600"/>
            <a:ext cx="4114800" cy="8380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ctr">
            <a:noAutofit/>
          </a:bodyPr>
          <a:p>
            <a:pPr indent="0" algn="ctr"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28600" y="1172880"/>
            <a:ext cx="2007720" cy="331956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337120" y="1172880"/>
            <a:ext cx="2007720" cy="15832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337120" y="2907000"/>
            <a:ext cx="2007720" cy="15832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B408FB-5C0D-4977-ABB4-5F934E3BF8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28600" y="201600"/>
            <a:ext cx="4114800" cy="8380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ctr">
            <a:noAutofit/>
          </a:bodyPr>
          <a:p>
            <a:pPr indent="0" algn="ctr"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28600" y="1172880"/>
            <a:ext cx="2007720" cy="15832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337120" y="1172880"/>
            <a:ext cx="2007720" cy="15832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28600" y="2907000"/>
            <a:ext cx="4114800" cy="15832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71AE51-A91E-489C-9FB5-84AF2339B8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28600" y="201600"/>
            <a:ext cx="4114800" cy="83808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ctr">
            <a:noAutofit/>
          </a:bodyPr>
          <a:p>
            <a:pPr indent="0" algn="ctr"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28600" y="1172880"/>
            <a:ext cx="4114800" cy="331956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t">
            <a:normAutofit/>
          </a:bodyPr>
          <a:p>
            <a:pPr marL="204840" indent="-204840">
              <a:spcBef>
                <a:spcPts val="476"/>
              </a:spcBef>
              <a:buClr>
                <a:srgbClr val="000000"/>
              </a:buClr>
              <a:buFont typeface="Arial"/>
              <a:buChar char="•"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1" marL="444600" indent="-169920">
              <a:spcBef>
                <a:spcPts val="476"/>
              </a:spcBef>
              <a:buClr>
                <a:srgbClr val="000000"/>
              </a:buClr>
              <a:buFont typeface="Arial"/>
              <a:buChar char="–"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2" marL="684360" indent="-136800">
              <a:spcBef>
                <a:spcPts val="476"/>
              </a:spcBef>
              <a:buClr>
                <a:srgbClr val="000000"/>
              </a:buClr>
              <a:buFont typeface="Arial"/>
              <a:buChar char="•"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3" marL="958680" indent="-136440">
              <a:spcBef>
                <a:spcPts val="476"/>
              </a:spcBef>
              <a:buClr>
                <a:srgbClr val="000000"/>
              </a:buClr>
              <a:buFont typeface="Arial"/>
              <a:buChar char="–"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4" marL="1233360" indent="-136440">
              <a:spcBef>
                <a:spcPts val="476"/>
              </a:spcBef>
              <a:buClr>
                <a:srgbClr val="000000"/>
              </a:buClr>
              <a:buFont typeface="Arial"/>
              <a:buChar char="»"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5" marL="1233360" indent="-136440">
              <a:spcBef>
                <a:spcPts val="476"/>
              </a:spcBef>
              <a:buClr>
                <a:srgbClr val="000000"/>
              </a:buClr>
              <a:buFont typeface="Arial"/>
              <a:buChar char="»"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6" marL="1233360" indent="-136440">
              <a:spcBef>
                <a:spcPts val="476"/>
              </a:spcBef>
              <a:buClr>
                <a:srgbClr val="000000"/>
              </a:buClr>
              <a:buFont typeface="Arial"/>
              <a:buChar char="»"/>
              <a:tabLst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28240" y="4660560"/>
            <a:ext cx="1066680" cy="26820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  <a:defRPr b="0" lang="en-US" sz="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7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562040" y="4660560"/>
            <a:ext cx="1447920" cy="26820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ctr">
            <a:noAutofit/>
          </a:bodyPr>
          <a:p>
            <a:pPr indent="0"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276360" y="4660560"/>
            <a:ext cx="1066680" cy="268200"/>
          </a:xfrm>
          <a:prstGeom prst="rect">
            <a:avLst/>
          </a:prstGeom>
          <a:noFill/>
          <a:ln w="0">
            <a:noFill/>
          </a:ln>
        </p:spPr>
        <p:txBody>
          <a:bodyPr lIns="54720" rIns="54720" tIns="27360" bIns="2736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  <a:defRPr b="0" lang="en-US" sz="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fld id="{41043694-3737-4462-9DEB-B02B26433E2B}" type="slidenum">
              <a:rPr b="0" lang="en-US" sz="7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Chart 110" descr=""/>
          <p:cNvPicPr/>
          <p:nvPr/>
        </p:nvPicPr>
        <p:blipFill>
          <a:blip r:embed="rId1"/>
          <a:stretch/>
        </p:blipFill>
        <p:spPr>
          <a:xfrm>
            <a:off x="6480" y="-85680"/>
            <a:ext cx="6016320" cy="3664080"/>
          </a:xfrm>
          <a:prstGeom prst="rect">
            <a:avLst/>
          </a:prstGeom>
          <a:ln w="0">
            <a:noFill/>
          </a:ln>
        </p:spPr>
      </p:pic>
      <p:sp>
        <p:nvSpPr>
          <p:cNvPr id="49" name="Straight Connector 111"/>
          <p:cNvSpPr/>
          <p:nvPr/>
        </p:nvSpPr>
        <p:spPr>
          <a:xfrm>
            <a:off x="2374920" y="419040"/>
            <a:ext cx="0" cy="152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Straight Connector 112"/>
          <p:cNvSpPr/>
          <p:nvPr/>
        </p:nvSpPr>
        <p:spPr>
          <a:xfrm>
            <a:off x="4051440" y="419040"/>
            <a:ext cx="0" cy="152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13"/>
          <p:cNvSpPr/>
          <p:nvPr/>
        </p:nvSpPr>
        <p:spPr>
          <a:xfrm>
            <a:off x="930240" y="152280"/>
            <a:ext cx="71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enth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Straight Connector 114"/>
          <p:cNvSpPr/>
          <p:nvPr/>
        </p:nvSpPr>
        <p:spPr>
          <a:xfrm>
            <a:off x="927000" y="457200"/>
            <a:ext cx="3124440" cy="32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15"/>
          <p:cNvSpPr/>
          <p:nvPr/>
        </p:nvSpPr>
        <p:spPr>
          <a:xfrm>
            <a:off x="2909880" y="466560"/>
            <a:ext cx="72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a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2+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-fre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4" name="Straight Arrow Connector 116"/>
          <p:cNvCxnSpPr/>
          <p:nvPr/>
        </p:nvCxnSpPr>
        <p:spPr>
          <a:xfrm>
            <a:off x="3660840" y="571680"/>
            <a:ext cx="381600" cy="216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55" name="Straight Arrow Connector 117"/>
          <p:cNvCxnSpPr/>
          <p:nvPr/>
        </p:nvCxnSpPr>
        <p:spPr>
          <a:xfrm flipH="1" flipV="1">
            <a:off x="2374560" y="571320"/>
            <a:ext cx="534240" cy="216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56" name="Straight Connector 118"/>
          <p:cNvSpPr/>
          <p:nvPr/>
        </p:nvSpPr>
        <p:spPr>
          <a:xfrm>
            <a:off x="698400" y="3486240"/>
            <a:ext cx="37497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Straight Connector 119"/>
          <p:cNvSpPr/>
          <p:nvPr/>
        </p:nvSpPr>
        <p:spPr>
          <a:xfrm flipH="1">
            <a:off x="1211400" y="3497400"/>
            <a:ext cx="288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Straight Connector 120"/>
          <p:cNvSpPr/>
          <p:nvPr/>
        </p:nvSpPr>
        <p:spPr>
          <a:xfrm flipH="1">
            <a:off x="1735200" y="3505320"/>
            <a:ext cx="144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Straight Connector 121"/>
          <p:cNvSpPr/>
          <p:nvPr/>
        </p:nvSpPr>
        <p:spPr>
          <a:xfrm flipH="1">
            <a:off x="2257560" y="3494160"/>
            <a:ext cx="144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Straight Connector 122"/>
          <p:cNvSpPr/>
          <p:nvPr/>
        </p:nvSpPr>
        <p:spPr>
          <a:xfrm flipH="1">
            <a:off x="2781360" y="3494160"/>
            <a:ext cx="144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Straight Connector 123"/>
          <p:cNvSpPr/>
          <p:nvPr/>
        </p:nvSpPr>
        <p:spPr>
          <a:xfrm flipH="1">
            <a:off x="3303720" y="3502080"/>
            <a:ext cx="144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Straight Connector 124"/>
          <p:cNvSpPr/>
          <p:nvPr/>
        </p:nvSpPr>
        <p:spPr>
          <a:xfrm flipH="1">
            <a:off x="3827520" y="3502080"/>
            <a:ext cx="144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Straight Connector 125"/>
          <p:cNvSpPr/>
          <p:nvPr/>
        </p:nvSpPr>
        <p:spPr>
          <a:xfrm flipH="1">
            <a:off x="4349880" y="3500280"/>
            <a:ext cx="144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126"/>
          <p:cNvSpPr/>
          <p:nvPr/>
        </p:nvSpPr>
        <p:spPr>
          <a:xfrm>
            <a:off x="1053000" y="3629160"/>
            <a:ext cx="324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5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127"/>
          <p:cNvSpPr/>
          <p:nvPr/>
        </p:nvSpPr>
        <p:spPr>
          <a:xfrm>
            <a:off x="1577520" y="3629160"/>
            <a:ext cx="395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1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128"/>
          <p:cNvSpPr/>
          <p:nvPr/>
        </p:nvSpPr>
        <p:spPr>
          <a:xfrm>
            <a:off x="2101680" y="3619440"/>
            <a:ext cx="395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15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129"/>
          <p:cNvSpPr/>
          <p:nvPr/>
        </p:nvSpPr>
        <p:spPr>
          <a:xfrm>
            <a:off x="2634840" y="3610080"/>
            <a:ext cx="395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2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130"/>
          <p:cNvSpPr/>
          <p:nvPr/>
        </p:nvSpPr>
        <p:spPr>
          <a:xfrm>
            <a:off x="3149280" y="3610080"/>
            <a:ext cx="395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25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131"/>
          <p:cNvSpPr/>
          <p:nvPr/>
        </p:nvSpPr>
        <p:spPr>
          <a:xfrm>
            <a:off x="3663720" y="3600360"/>
            <a:ext cx="395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3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132"/>
          <p:cNvSpPr/>
          <p:nvPr/>
        </p:nvSpPr>
        <p:spPr>
          <a:xfrm>
            <a:off x="4187520" y="3600360"/>
            <a:ext cx="395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35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133"/>
          <p:cNvSpPr/>
          <p:nvPr/>
        </p:nvSpPr>
        <p:spPr>
          <a:xfrm>
            <a:off x="2380680" y="3886200"/>
            <a:ext cx="75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ime (s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134"/>
          <p:cNvSpPr/>
          <p:nvPr/>
        </p:nvSpPr>
        <p:spPr>
          <a:xfrm rot="16200000">
            <a:off x="-751680" y="1608120"/>
            <a:ext cx="1837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Menthol Response (∆F/Fo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135"/>
          <p:cNvSpPr/>
          <p:nvPr/>
        </p:nvSpPr>
        <p:spPr>
          <a:xfrm>
            <a:off x="4146480" y="184320"/>
            <a:ext cx="654120" cy="304776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547560"/>
                <a:tab algn="l" pos="1095480"/>
                <a:tab algn="l" pos="1643040"/>
                <a:tab algn="l" pos="2190600"/>
                <a:tab algn="l" pos="2738520"/>
                <a:tab algn="l" pos="3286080"/>
                <a:tab algn="l" pos="3833640"/>
                <a:tab algn="l" pos="4381560"/>
                <a:tab algn="l" pos="4929120"/>
                <a:tab algn="l" pos="5477040"/>
                <a:tab algn="l" pos="6024600"/>
                <a:tab algn="l" pos="6572160"/>
                <a:tab algn="l" pos="7120080"/>
                <a:tab algn="l" pos="7667640"/>
                <a:tab algn="l" pos="8215200"/>
                <a:tab algn="l" pos="8763120"/>
                <a:tab algn="l" pos="9310680"/>
                <a:tab algn="l" pos="9858240"/>
                <a:tab algn="l" pos="10406160"/>
                <a:tab algn="l" pos="1095372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1"/>
          <p:cNvSpPr/>
          <p:nvPr/>
        </p:nvSpPr>
        <p:spPr>
          <a:xfrm>
            <a:off x="241200" y="4194000"/>
            <a:ext cx="44960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Figure. 2.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The figure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shows a rapid reduction of menthol response when normal bath solution is replaced by a Ca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2+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-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free bath solution during prolonged menthol application. Similar results were obtained in 2 other cell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28T13:35:38Z</dcterms:created>
  <dc:creator>Jianguo Gu</dc:creator>
  <dc:description/>
  <dc:language>en-US</dc:language>
  <cp:lastModifiedBy>sarriaio</cp:lastModifiedBy>
  <dcterms:modified xsi:type="dcterms:W3CDTF">2010-08-11T17:05:29Z</dcterms:modified>
  <cp:revision>7</cp:revision>
  <dc:subject/>
  <dc:title>Slide 1</dc:title>
</cp:coreProperties>
</file>